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366A8F-C65C-457D-A58B-F380B205EF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6E10C5B-6453-45A2-A649-4B88D7C4F3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8EC0AF-A39C-4D45-83D7-0C1443EE6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8757889-790C-499B-8230-A8AEF4BCF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D92E0E-B5C2-4526-906B-C9A3962C9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781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CA261-15F7-48BB-AB6B-914CDB857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DBFEAB-4273-4305-BF84-A1CE2F4913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923F4C-A0BD-4D3B-8246-14A86C874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94060A-3E2D-482B-A8AF-25812DDB2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78B41C-C150-4F89-BD9B-D74D2D0BF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27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4B128F-556D-47E1-9A7F-2A24FA3842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441DB6-FB02-4180-B5C9-FD863CD308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74334E-E322-4EE8-947E-D5D0E1C15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28A610-AA16-4DE7-ABEA-AF9284B74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D3C7DD-60AF-480E-BD9D-40B3B8576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0548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69A1F1-F8D9-47A4-B765-851A52A41A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DE0F9A-8BBD-46BB-AB9F-DA1AE67E21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BDCD26-A0FA-456A-8AB5-E25FAA53B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93EFBF-D6B1-4931-910E-172C71037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07ED8B-0987-4726-9484-E312102C4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1899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DCDD17-55B5-4314-B030-7C2CF39B9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B37632-CE15-4C6E-AF8F-1557278D87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3ACE40-A07A-483C-832A-87D2FCD66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D8AADC-7DAA-4ABF-931B-5EFF1B49E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201B04-2708-4B81-838E-2F6176A8E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938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59BB41-DB95-4F64-9D33-3FCFF7A6C1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5A807F-32A6-4BC9-AEC6-878921E12C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A515C5F-F545-428C-A61F-C51E721F47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88F774-252A-4158-BF6F-EA055012D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9DE33B-B395-41DE-BA7F-67FF2C836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7CA271-95AC-42A1-83BC-1E62E9E02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7716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F7C12C-D8C9-4E15-8BE7-F968E1D405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FA66011-CE0A-4BEB-942A-DB55514772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368F3B1-1083-4DF4-966F-DBA18A7751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6FA9834-BBBF-481F-8EC0-53B9E09CAC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1A9509-BA1F-4071-8883-2562A58440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8F0AFBD-42C1-4884-97F2-80A56BE05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DA45D42-8A8A-4252-B6C0-143239EE1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0087331-F24A-405C-B9E4-A44DB7570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265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36D153-1435-4EAD-855D-BF21BE28AB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74A0631-B578-4A9B-8563-4F520268C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B454250-7D13-4702-99EB-6E523AE98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52F581F-DCEE-420C-9D21-70ADC2007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581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949F70F-01A5-4397-9D06-66EF6270E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6D9449C-F6BC-4657-A590-18C316CA2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BDBEF53-AEA6-4B6D-A1F0-940C31390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575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1DCFE0-F9AA-4E3E-BCF4-E08DA5570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3DF94E-EDF6-4FD5-8FF9-55F3877648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2F5BE0B-E4DB-4265-8FB1-B3FE8B3D63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05FBB5-4DD8-4615-8FB8-E1B1AD64B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1EC8F6-C7BB-4DEC-9CF3-A7257869A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B96677-70F3-476D-ACE0-99922FDDC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999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6622DF-7713-486A-872C-EB09014F19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F2340D3-328F-466C-B07F-87A80AD14B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DDC2F13-D14C-4AD7-80E6-429FCAD27C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C91E89-26BA-4560-A2B1-F241B6DD6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39E091F-5F96-4D43-8E4E-7E010FD2B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F842A7-8FE1-4FF0-8FC0-ED97C13C3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992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64467BD-022E-4583-AF7F-1145D0E6C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5EDECF-D98F-4A38-93AB-4E0AA3A0BD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378B06-4114-49A1-A9B8-E1989364E0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8C7E5-C26E-4A6C-A6F9-0C0B0912A369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2E69AC-67ED-4E05-96E0-912E9E6A08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A2E010-531F-43C6-841B-87AFB56A5A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ACC5E-AEB1-4FB2-B2B7-6AFE5DD4B7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230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9A17424-4653-40C4-8C20-BAEE580E88D0}"/>
              </a:ext>
            </a:extLst>
          </p:cNvPr>
          <p:cNvSpPr txBox="1"/>
          <p:nvPr/>
        </p:nvSpPr>
        <p:spPr>
          <a:xfrm>
            <a:off x="962025" y="5368332"/>
            <a:ext cx="100599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2 S</a:t>
            </a:r>
            <a:r>
              <a:rPr lang="en-US" altLang="ja-JP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ematic diagram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the plastic deformation on the FPB treated surface due to a single bombardment of fine particle on the substrate. The distance between the convexity to convexity is defined as the roughness pitch.</a:t>
            </a:r>
            <a:endParaRPr lang="ja-JP" altLang="ja-JP" sz="18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AA27F0B5-2EDC-49D2-877E-CBBCFDF153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3246" y="1615283"/>
            <a:ext cx="6157494" cy="36274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3250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40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magai</dc:creator>
  <cp:lastModifiedBy>kodama nishitani tomoko</cp:lastModifiedBy>
  <cp:revision>9</cp:revision>
  <dcterms:created xsi:type="dcterms:W3CDTF">2022-01-01T19:43:26Z</dcterms:created>
  <dcterms:modified xsi:type="dcterms:W3CDTF">2022-01-14T02:27:18Z</dcterms:modified>
</cp:coreProperties>
</file>